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6" r:id="rId3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30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88A38F-A7B9-45C1-96FC-A7A3B1F4801E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C26728-10D2-40D1-AA57-1CF0F7DF7D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62018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C26728-10D2-40D1-AA57-1CF0F7DF7DE1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29405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9478D-FC99-4A31-BDD6-0FC8B543CCA8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F8E20-B1EF-4747-9D21-754AAC0D7E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569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9478D-FC99-4A31-BDD6-0FC8B543CCA8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F8E20-B1EF-4747-9D21-754AAC0D7E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11425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9478D-FC99-4A31-BDD6-0FC8B543CCA8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F8E20-B1EF-4747-9D21-754AAC0D7E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88243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9478D-FC99-4A31-BDD6-0FC8B543CCA8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F8E20-B1EF-4747-9D21-754AAC0D7E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0241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9478D-FC99-4A31-BDD6-0FC8B543CCA8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F8E20-B1EF-4747-9D21-754AAC0D7E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3109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9478D-FC99-4A31-BDD6-0FC8B543CCA8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F8E20-B1EF-4747-9D21-754AAC0D7E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36642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9478D-FC99-4A31-BDD6-0FC8B543CCA8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F8E20-B1EF-4747-9D21-754AAC0D7E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1674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9478D-FC99-4A31-BDD6-0FC8B543CCA8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F8E20-B1EF-4747-9D21-754AAC0D7E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92914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9478D-FC99-4A31-BDD6-0FC8B543CCA8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F8E20-B1EF-4747-9D21-754AAC0D7E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53211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9478D-FC99-4A31-BDD6-0FC8B543CCA8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F8E20-B1EF-4747-9D21-754AAC0D7E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24899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9478D-FC99-4A31-BDD6-0FC8B543CCA8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F8E20-B1EF-4747-9D21-754AAC0D7E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05325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69478D-FC99-4A31-BDD6-0FC8B543CCA8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8F8E20-B1EF-4747-9D21-754AAC0D7E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43297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457200" y="609600"/>
            <a:ext cx="8229600" cy="5516563"/>
          </a:xfrm>
        </p:spPr>
        <p:txBody>
          <a:bodyPr>
            <a:noAutofit/>
          </a:bodyPr>
          <a:lstStyle/>
          <a:p>
            <a:pPr marL="0" indent="0" algn="ctr">
              <a:buNone/>
            </a:pPr>
            <a:r>
              <a:rPr lang="es-ES" sz="1600" b="1" dirty="0" err="1">
                <a:latin typeface="Arial" pitchFamily="34" charset="0"/>
                <a:cs typeface="Arial" pitchFamily="34" charset="0"/>
              </a:rPr>
              <a:t>Linkage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disequilibrium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patterns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,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population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structure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and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diversity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analysis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in a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worldwide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durum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wheat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collection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including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Argentinian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genotypes</a:t>
            </a:r>
            <a:endParaRPr lang="es-ES" sz="1600" b="1" dirty="0">
              <a:latin typeface="Arial" pitchFamily="34" charset="0"/>
              <a:cs typeface="Arial" pitchFamily="34" charset="0"/>
            </a:endParaRPr>
          </a:p>
          <a:p>
            <a:pPr marL="0" indent="0" algn="ctr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 algn="ctr">
              <a:buNone/>
            </a:pPr>
            <a:r>
              <a:rPr lang="es-ES" sz="1600" dirty="0">
                <a:latin typeface="Arial" pitchFamily="34" charset="0"/>
                <a:cs typeface="Arial" pitchFamily="34" charset="0"/>
              </a:rPr>
              <a:t>Pablo Federico Roncallo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Adelina Olga Larsen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2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Ana Laura Achilli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Carolina Saint </a:t>
            </a:r>
            <a:r>
              <a:rPr lang="es-ES" sz="1600" dirty="0" smtClean="0">
                <a:latin typeface="Arial" pitchFamily="34" charset="0"/>
                <a:cs typeface="Arial" pitchFamily="34" charset="0"/>
              </a:rPr>
              <a:t>Pierre</a:t>
            </a:r>
            <a:r>
              <a:rPr lang="es-ES" sz="1600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Cristian Andrés Gallo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Susanne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Dreisigacker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3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Viviana Echenique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*</a:t>
            </a:r>
          </a:p>
          <a:p>
            <a:pPr marL="0" indent="0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r>
              <a:rPr lang="es-ES" sz="1600" baseline="30000" dirty="0" smtClean="0">
                <a:latin typeface="Arial" pitchFamily="34" charset="0"/>
                <a:cs typeface="Arial" pitchFamily="34" charset="0"/>
              </a:rPr>
              <a:t>1</a:t>
            </a:r>
            <a:r>
              <a:rPr lang="es-ES" sz="1600" dirty="0" smtClean="0">
                <a:latin typeface="Arial" pitchFamily="34" charset="0"/>
                <a:cs typeface="Arial" pitchFamily="34" charset="0"/>
              </a:rPr>
              <a:t> Centro 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de Recursos Naturales Renovables de la Zona Semiárida (CERZOS), Departamento de Agronomía, Universidad Nacional del Sur (UNS)-CONICET, Bahía Blanca, Argentina.</a:t>
            </a:r>
          </a:p>
          <a:p>
            <a:pPr marL="0" indent="0">
              <a:buNone/>
            </a:pPr>
            <a:r>
              <a:rPr lang="es-ES" sz="1600" baseline="30000" dirty="0">
                <a:latin typeface="Arial" pitchFamily="34" charset="0"/>
                <a:cs typeface="Arial" pitchFamily="34" charset="0"/>
              </a:rPr>
              <a:t>2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CEI Barrow, Instituto Nacional de Tecnología Agropecuaria (INTA), Tres Arroyos, Buenos Aires, Argentina. </a:t>
            </a:r>
          </a:p>
          <a:p>
            <a:pPr marL="0" indent="0">
              <a:buNone/>
            </a:pPr>
            <a:r>
              <a:rPr lang="es-ES" sz="1600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s-ES" sz="1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International 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Maize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and 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Wheat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Improvement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Center (CIMMYT), El Batán, Edo. de México, México.</a:t>
            </a:r>
          </a:p>
          <a:p>
            <a:pPr marL="0" indent="0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r>
              <a:rPr lang="es-ES" sz="1600" dirty="0">
                <a:latin typeface="Arial" pitchFamily="34" charset="0"/>
                <a:cs typeface="Arial" pitchFamily="34" charset="0"/>
              </a:rPr>
              <a:t>*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Corresponding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author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: </a:t>
            </a:r>
          </a:p>
          <a:p>
            <a:pPr marL="0" indent="0">
              <a:buNone/>
            </a:pPr>
            <a:r>
              <a:rPr lang="es-ES" sz="1600" dirty="0">
                <a:latin typeface="Arial" pitchFamily="34" charset="0"/>
                <a:cs typeface="Arial" pitchFamily="34" charset="0"/>
              </a:rPr>
              <a:t>E-mail: echeniq@criba.edu.ar</a:t>
            </a:r>
          </a:p>
          <a:p>
            <a:endParaRPr lang="es-ES" sz="1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60318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3016" y="415101"/>
            <a:ext cx="4475056" cy="2794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596" y="535937"/>
            <a:ext cx="4465515" cy="27527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12 CuadroTexto"/>
          <p:cNvSpPr txBox="1"/>
          <p:nvPr/>
        </p:nvSpPr>
        <p:spPr>
          <a:xfrm>
            <a:off x="380799" y="290450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b="1" dirty="0"/>
              <a:t>a</a:t>
            </a:r>
            <a:endParaRPr lang="es-ES" b="1" dirty="0"/>
          </a:p>
        </p:txBody>
      </p:sp>
      <p:sp>
        <p:nvSpPr>
          <p:cNvPr id="14" name="13 CuadroTexto"/>
          <p:cNvSpPr txBox="1"/>
          <p:nvPr/>
        </p:nvSpPr>
        <p:spPr>
          <a:xfrm>
            <a:off x="353503" y="333845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b="1" dirty="0" smtClean="0"/>
              <a:t>b</a:t>
            </a:r>
            <a:endParaRPr lang="es-ES" b="1" dirty="0"/>
          </a:p>
        </p:txBody>
      </p:sp>
      <p:sp>
        <p:nvSpPr>
          <p:cNvPr id="15" name="14 CuadroTexto"/>
          <p:cNvSpPr txBox="1"/>
          <p:nvPr/>
        </p:nvSpPr>
        <p:spPr>
          <a:xfrm>
            <a:off x="4884760" y="290450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b="1" dirty="0" smtClean="0"/>
              <a:t>c</a:t>
            </a:r>
            <a:endParaRPr lang="es-ES" b="1" dirty="0"/>
          </a:p>
        </p:txBody>
      </p:sp>
      <p:sp>
        <p:nvSpPr>
          <p:cNvPr id="16" name="15 CuadroTexto"/>
          <p:cNvSpPr txBox="1"/>
          <p:nvPr/>
        </p:nvSpPr>
        <p:spPr>
          <a:xfrm>
            <a:off x="4876800" y="333845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b="1" dirty="0" smtClean="0"/>
              <a:t>d</a:t>
            </a:r>
            <a:endParaRPr lang="es-ES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3696" y="3636649"/>
            <a:ext cx="4475056" cy="27897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028" y="3719450"/>
            <a:ext cx="4465515" cy="2757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013268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35</TotalTime>
  <Words>127</Words>
  <Application>Microsoft Office PowerPoint</Application>
  <PresentationFormat>Presentación en pantalla (4:3)</PresentationFormat>
  <Paragraphs>18</Paragraphs>
  <Slides>2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Presentación de PowerPoint</vt:lpstr>
      <vt:lpstr>Presentación de PowerPoint</vt:lpstr>
    </vt:vector>
  </TitlesOfParts>
  <Company>Luff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blo Roncallo</dc:creator>
  <cp:lastModifiedBy>Pablo Roncallo</cp:lastModifiedBy>
  <cp:revision>20</cp:revision>
  <dcterms:created xsi:type="dcterms:W3CDTF">2020-08-07T00:02:31Z</dcterms:created>
  <dcterms:modified xsi:type="dcterms:W3CDTF">2021-01-06T10:58:07Z</dcterms:modified>
</cp:coreProperties>
</file>